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avi" ContentType="video/x-msvide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8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7" autoAdjust="0"/>
    <p:restoredTop sz="94660"/>
  </p:normalViewPr>
  <p:slideViewPr>
    <p:cSldViewPr snapToGrid="0" showGuides="1">
      <p:cViewPr varScale="1">
        <p:scale>
          <a:sx n="63" d="100"/>
          <a:sy n="63" d="100"/>
        </p:scale>
        <p:origin x="2160" y="7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081E45-73EA-44E2-B56A-4BAD5A22EB64}" type="datetimeFigureOut">
              <a:rPr lang="en-GB" smtClean="0"/>
              <a:t>28/02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0BDB079-9430-4DAE-BCA3-28C1FB6A39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41341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B6CA14-E494-451A-BE41-B8A4BC9B4B35}" type="datetimeFigureOut">
              <a:rPr lang="en-GB" smtClean="0"/>
              <a:t>28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DC6FE-32E2-4AF9-9966-B8F4F63E226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20413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B6CA14-E494-451A-BE41-B8A4BC9B4B35}" type="datetimeFigureOut">
              <a:rPr lang="en-GB" smtClean="0"/>
              <a:t>28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DC6FE-32E2-4AF9-9966-B8F4F63E226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28059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B6CA14-E494-451A-BE41-B8A4BC9B4B35}" type="datetimeFigureOut">
              <a:rPr lang="en-GB" smtClean="0"/>
              <a:t>28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DC6FE-32E2-4AF9-9966-B8F4F63E226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58988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B6CA14-E494-451A-BE41-B8A4BC9B4B35}" type="datetimeFigureOut">
              <a:rPr lang="en-GB" smtClean="0"/>
              <a:t>28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DC6FE-32E2-4AF9-9966-B8F4F63E226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01639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B6CA14-E494-451A-BE41-B8A4BC9B4B35}" type="datetimeFigureOut">
              <a:rPr lang="en-GB" smtClean="0"/>
              <a:t>28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DC6FE-32E2-4AF9-9966-B8F4F63E226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29068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B6CA14-E494-451A-BE41-B8A4BC9B4B35}" type="datetimeFigureOut">
              <a:rPr lang="en-GB" smtClean="0"/>
              <a:t>28/0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DC6FE-32E2-4AF9-9966-B8F4F63E226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47401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B6CA14-E494-451A-BE41-B8A4BC9B4B35}" type="datetimeFigureOut">
              <a:rPr lang="en-GB" smtClean="0"/>
              <a:t>28/02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DC6FE-32E2-4AF9-9966-B8F4F63E226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20802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B6CA14-E494-451A-BE41-B8A4BC9B4B35}" type="datetimeFigureOut">
              <a:rPr lang="en-GB" smtClean="0"/>
              <a:t>28/02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DC6FE-32E2-4AF9-9966-B8F4F63E226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26481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B6CA14-E494-451A-BE41-B8A4BC9B4B35}" type="datetimeFigureOut">
              <a:rPr lang="en-GB" smtClean="0"/>
              <a:t>28/02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DC6FE-32E2-4AF9-9966-B8F4F63E226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73198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B6CA14-E494-451A-BE41-B8A4BC9B4B35}" type="datetimeFigureOut">
              <a:rPr lang="en-GB" smtClean="0"/>
              <a:t>28/0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DC6FE-32E2-4AF9-9966-B8F4F63E226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40266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B6CA14-E494-451A-BE41-B8A4BC9B4B35}" type="datetimeFigureOut">
              <a:rPr lang="en-GB" smtClean="0"/>
              <a:t>28/0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DC6FE-32E2-4AF9-9966-B8F4F63E226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139050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B6CA14-E494-451A-BE41-B8A4BC9B4B35}" type="datetimeFigureOut">
              <a:rPr lang="en-GB" smtClean="0"/>
              <a:t>28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EDC6FE-32E2-4AF9-9966-B8F4F63E226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53188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z-stack macgreen phalloidin-red jacalin-blue 2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4"/>
          <a:srcRect l="24329" r="18358"/>
          <a:stretch/>
        </p:blipFill>
        <p:spPr>
          <a:xfrm>
            <a:off x="970936" y="1263224"/>
            <a:ext cx="5045007" cy="5230552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4010734" y="205702"/>
            <a:ext cx="2532232" cy="38869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b="1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Movie 1.</a:t>
            </a:r>
            <a:endParaRPr lang="en-GB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970936" y="6680762"/>
            <a:ext cx="5045006" cy="24632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b="1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Movie 1. </a:t>
            </a:r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Movie of an individual bursal follicle demonstrating that the </a:t>
            </a:r>
            <a:r>
              <a:rPr lang="en-GB" i="1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SF1R</a:t>
            </a:r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-eGFP+ FAE cells (green) express high levels of apically localised F-actin (red) in comparison to </a:t>
            </a:r>
            <a:r>
              <a:rPr lang="en-GB" dirty="0" err="1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Jacalin</a:t>
            </a:r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lectin staining FAE or IFE cells (blue</a:t>
            </a:r>
            <a:r>
              <a:rPr lang="en-GB" dirty="0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. View is initially of the mucosal surface</a:t>
            </a:r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centred on the FAE. </a:t>
            </a:r>
            <a:r>
              <a:rPr lang="en-GB" dirty="0"/>
              <a:t>Representative of 5-15 individual follicles. </a:t>
            </a:r>
            <a:r>
              <a:rPr lang="en-GB"/>
              <a:t>Scale bar = 10 µm.</a:t>
            </a:r>
            <a:endParaRPr lang="en-GB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4436700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72</Words>
  <Application>Microsoft Office PowerPoint</Application>
  <PresentationFormat>On-screen Show (4:3)</PresentationFormat>
  <Paragraphs>2</Paragraphs>
  <Slides>1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of Edinburgh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LIC Adam</dc:creator>
  <cp:lastModifiedBy>BALIC Adam</cp:lastModifiedBy>
  <cp:revision>2</cp:revision>
  <dcterms:created xsi:type="dcterms:W3CDTF">2019-02-27T14:44:25Z</dcterms:created>
  <dcterms:modified xsi:type="dcterms:W3CDTF">2019-02-28T09:09:52Z</dcterms:modified>
</cp:coreProperties>
</file>